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432" autoAdjust="0"/>
    <p:restoredTop sz="94235" autoAdjust="0"/>
  </p:normalViewPr>
  <p:slideViewPr>
    <p:cSldViewPr snapToGrid="0">
      <p:cViewPr varScale="1">
        <p:scale>
          <a:sx n="82" d="100"/>
          <a:sy n="82" d="100"/>
        </p:scale>
        <p:origin x="-114" y="-54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E4EA8A-6D5D-400A-9069-33466924C66F}" type="datetimeFigureOut">
              <a:rPr lang="en-US" smtClean="0"/>
              <a:t>6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F6565-D495-42EA-B277-9D6D83FB5A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2976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E4EA8A-6D5D-400A-9069-33466924C66F}" type="datetimeFigureOut">
              <a:rPr lang="en-US" smtClean="0"/>
              <a:t>6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F6565-D495-42EA-B277-9D6D83FB5A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91296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E4EA8A-6D5D-400A-9069-33466924C66F}" type="datetimeFigureOut">
              <a:rPr lang="en-US" smtClean="0"/>
              <a:t>6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F6565-D495-42EA-B277-9D6D83FB5A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63515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E4EA8A-6D5D-400A-9069-33466924C66F}" type="datetimeFigureOut">
              <a:rPr lang="en-US" smtClean="0"/>
              <a:t>6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F6565-D495-42EA-B277-9D6D83FB5A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16504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E4EA8A-6D5D-400A-9069-33466924C66F}" type="datetimeFigureOut">
              <a:rPr lang="en-US" smtClean="0"/>
              <a:t>6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F6565-D495-42EA-B277-9D6D83FB5A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31221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E4EA8A-6D5D-400A-9069-33466924C66F}" type="datetimeFigureOut">
              <a:rPr lang="en-US" smtClean="0"/>
              <a:t>6/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F6565-D495-42EA-B277-9D6D83FB5A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08958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E4EA8A-6D5D-400A-9069-33466924C66F}" type="datetimeFigureOut">
              <a:rPr lang="en-US" smtClean="0"/>
              <a:t>6/8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F6565-D495-42EA-B277-9D6D83FB5A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09482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E4EA8A-6D5D-400A-9069-33466924C66F}" type="datetimeFigureOut">
              <a:rPr lang="en-US" smtClean="0"/>
              <a:t>6/8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F6565-D495-42EA-B277-9D6D83FB5A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65322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E4EA8A-6D5D-400A-9069-33466924C66F}" type="datetimeFigureOut">
              <a:rPr lang="en-US" smtClean="0"/>
              <a:t>6/8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F6565-D495-42EA-B277-9D6D83FB5A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13328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E4EA8A-6D5D-400A-9069-33466924C66F}" type="datetimeFigureOut">
              <a:rPr lang="en-US" smtClean="0"/>
              <a:t>6/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F6565-D495-42EA-B277-9D6D83FB5A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53225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E4EA8A-6D5D-400A-9069-33466924C66F}" type="datetimeFigureOut">
              <a:rPr lang="en-US" smtClean="0"/>
              <a:t>6/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F6565-D495-42EA-B277-9D6D83FB5A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13736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E4EA8A-6D5D-400A-9069-33466924C66F}" type="datetimeFigureOut">
              <a:rPr lang="en-US" smtClean="0"/>
              <a:t>6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4F6565-D495-42EA-B277-9D6D83FB5A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9769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2503013" y="257174"/>
            <a:ext cx="7637907" cy="5819775"/>
            <a:chOff x="1779113" y="76200"/>
            <a:chExt cx="8900474" cy="6781800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62361"/>
            <a:stretch/>
          </p:blipFill>
          <p:spPr>
            <a:xfrm>
              <a:off x="1779113" y="76200"/>
              <a:ext cx="8900474" cy="2581275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95694"/>
            <a:stretch/>
          </p:blipFill>
          <p:spPr>
            <a:xfrm>
              <a:off x="1779113" y="6562725"/>
              <a:ext cx="8900474" cy="295275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4028" b="37639"/>
            <a:stretch/>
          </p:blipFill>
          <p:spPr>
            <a:xfrm>
              <a:off x="1779113" y="2657475"/>
              <a:ext cx="8900474" cy="1257300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792" b="46180"/>
            <a:stretch/>
          </p:blipFill>
          <p:spPr>
            <a:xfrm>
              <a:off x="1779113" y="3914775"/>
              <a:ext cx="8900474" cy="2676525"/>
            </a:xfrm>
            <a:prstGeom prst="rect">
              <a:avLst/>
            </a:prstGeom>
          </p:spPr>
        </p:pic>
      </p:grpSp>
      <p:sp>
        <p:nvSpPr>
          <p:cNvPr id="10" name="TextBox 9"/>
          <p:cNvSpPr txBox="1"/>
          <p:nvPr/>
        </p:nvSpPr>
        <p:spPr>
          <a:xfrm>
            <a:off x="180974" y="6076949"/>
            <a:ext cx="1187767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Figure S3: Effect of </a:t>
            </a:r>
            <a:r>
              <a:rPr lang="en-US" sz="1200" smtClean="0"/>
              <a:t>the </a:t>
            </a:r>
            <a:r>
              <a:rPr lang="en-US" sz="1200" smtClean="0"/>
              <a:t>presence </a:t>
            </a:r>
            <a:r>
              <a:rPr lang="en-US" sz="1200" dirty="0" smtClean="0"/>
              <a:t>of a deletion in a sample relative to the GBS reference allele.  A gapped alignment is formed and the 3’ end extends beyond the junction of the forward and reverse reads in the GBS reference resulting in the calling of a SNP at that position.  The Integrative Genomics Viewer (Robinson et al. 2011, Nature Biotechnology 29: 24-26; </a:t>
            </a:r>
            <a:r>
              <a:rPr lang="en-US" sz="1200" dirty="0" err="1" smtClean="0"/>
              <a:t>Thorvaldsdóttir</a:t>
            </a:r>
            <a:r>
              <a:rPr lang="en-US" sz="1200" dirty="0" smtClean="0"/>
              <a:t> et al. </a:t>
            </a:r>
            <a:r>
              <a:rPr lang="en-US" sz="1200" dirty="0"/>
              <a:t> </a:t>
            </a:r>
            <a:r>
              <a:rPr lang="en-US" sz="1200" dirty="0" smtClean="0"/>
              <a:t>2013, Briefings in Bioinformatics 14: 178-192) was used for visualization. 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9152388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1</TotalTime>
  <Words>90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eng Qi</dc:creator>
  <cp:lastModifiedBy>Capangan, Fritz</cp:lastModifiedBy>
  <cp:revision>13</cp:revision>
  <dcterms:created xsi:type="dcterms:W3CDTF">2017-07-14T16:03:51Z</dcterms:created>
  <dcterms:modified xsi:type="dcterms:W3CDTF">2018-06-08T11:50:24Z</dcterms:modified>
</cp:coreProperties>
</file>